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5" r:id="rId2"/>
    <p:sldId id="268" r:id="rId3"/>
    <p:sldId id="266" r:id="rId4"/>
    <p:sldId id="267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0493" autoAdjust="0"/>
  </p:normalViewPr>
  <p:slideViewPr>
    <p:cSldViewPr snapToGrid="0">
      <p:cViewPr varScale="1">
        <p:scale>
          <a:sx n="71" d="100"/>
          <a:sy n="71" d="100"/>
        </p:scale>
        <p:origin x="4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AA8252-E75C-499F-8D37-73C9561FAC3E}" type="datetimeFigureOut">
              <a:rPr lang="zh-CN" altLang="en-US" smtClean="0"/>
              <a:t>2022/3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11DF77-9EA5-4033-9B89-E86323D2D3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9281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1D7941-85CC-4BB9-943E-880777E3A235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50942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111DF77-9EA5-4033-9B89-E86323D2D396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75235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87DDA4-7927-48C7-9801-D97005F35F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8CE7438-2DA0-41ED-B503-535E3A32B0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5B6A24-89A3-4257-B5BD-1A58153BA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F81AD-6832-496E-A05F-ED678CE6D5CC}" type="datetimeFigureOut">
              <a:rPr lang="zh-CN" altLang="en-US" smtClean="0"/>
              <a:t>2022/3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31F38C-39FD-4BCB-AB1A-644B6DE623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4D246B-D550-4381-B67D-ED430547C2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4CFB0-9A41-43D5-A341-C8895FC400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695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A8B83C-47A2-4BBA-9999-E850249443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EF6A9B6-C628-45D0-9050-E87A1F3AA9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BF90E19-199C-40A2-B9E2-7B7A9AFC3D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F81AD-6832-496E-A05F-ED678CE6D5CC}" type="datetimeFigureOut">
              <a:rPr lang="zh-CN" altLang="en-US" smtClean="0"/>
              <a:t>2022/3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E0F7B8-45CC-4194-87E1-32953CB65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AF38BE-D705-45A5-921D-880BEC1CB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4CFB0-9A41-43D5-A341-C8895FC400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1518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F1048AB-EC7F-449B-B67E-D1A5BD61F0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FE7F991-ED3A-41D2-BA50-8E0B56B8A0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03FB145-575A-4EE5-B069-56A45DEA34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F81AD-6832-496E-A05F-ED678CE6D5CC}" type="datetimeFigureOut">
              <a:rPr lang="zh-CN" altLang="en-US" smtClean="0"/>
              <a:t>2022/3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6E46D6D-285F-425A-8796-524FE34F7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B273E3-010C-4643-85C7-F1F71ABB5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4CFB0-9A41-43D5-A341-C8895FC400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6350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3EFEBA-ECE8-4BC4-9DB5-13AE8D1C32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DA0C7A3-0E5D-4163-AA9C-B2FB342E40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C0FD53-E9FD-4AE6-BF5B-AFC509A32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F81AD-6832-496E-A05F-ED678CE6D5CC}" type="datetimeFigureOut">
              <a:rPr lang="zh-CN" altLang="en-US" smtClean="0"/>
              <a:t>2022/3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043C963-4863-4628-BBD7-BBFFF612AA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64828A-7C82-4288-A9C1-E0B34A592D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4CFB0-9A41-43D5-A341-C8895FC400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6986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DAA404-7CF5-4772-8FB3-C9C24F6960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BFD0FAF-6DB8-4D59-BD84-80D80E78D3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A9278D-3C2A-45C0-83F7-81BEA0A4F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F81AD-6832-496E-A05F-ED678CE6D5CC}" type="datetimeFigureOut">
              <a:rPr lang="zh-CN" altLang="en-US" smtClean="0"/>
              <a:t>2022/3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D1A0A2-83E1-4FCF-A4A5-AE2F6201EC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E39253-0884-424C-BF0A-1D7F3C25D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4CFB0-9A41-43D5-A341-C8895FC400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2985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615DA9-AAC0-4250-8521-668054B047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1C28914-3E28-4B76-8DA4-E4D2E42578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F51C021-58CB-4CBC-9673-64F58126CD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534FD1D-EF0F-481E-BF2A-9B4D38560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F81AD-6832-496E-A05F-ED678CE6D5CC}" type="datetimeFigureOut">
              <a:rPr lang="zh-CN" altLang="en-US" smtClean="0"/>
              <a:t>2022/3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E1FF9D5-98E3-471D-9D86-57B061B554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3D475B4-0047-47A5-9CB2-2042542A8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4CFB0-9A41-43D5-A341-C8895FC400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4990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0DC3BD-FB99-4E06-9B16-FB2CA1E402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4D7C50F-401E-483A-A8E0-F54F4C476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104528D-F7ED-4770-991F-ECBAE9813A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E32573D-8568-490A-9EEA-99CF1BD1AA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BE27674-4F94-44F2-B416-827F27D1D6D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65770C9-2C38-44A3-A750-7D852E41E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F81AD-6832-496E-A05F-ED678CE6D5CC}" type="datetimeFigureOut">
              <a:rPr lang="zh-CN" altLang="en-US" smtClean="0"/>
              <a:t>2022/3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9EA4CC5-5B4C-40C5-9700-A0568C7B7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9397DE6-4A96-4852-AC93-00A7FF9E9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4CFB0-9A41-43D5-A341-C8895FC400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94727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A606F3-EB7D-4A56-93FF-5F7865EB91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9268A4F-7AF4-4539-807B-1274E001BF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F81AD-6832-496E-A05F-ED678CE6D5CC}" type="datetimeFigureOut">
              <a:rPr lang="zh-CN" altLang="en-US" smtClean="0"/>
              <a:t>2022/3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455A896-1D98-48A4-960F-293D72273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DF63FA8-93BD-4E43-AF15-7DB0D2D96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4CFB0-9A41-43D5-A341-C8895FC400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375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4BD14DB-6436-4A26-AB25-9D241B7495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F81AD-6832-496E-A05F-ED678CE6D5CC}" type="datetimeFigureOut">
              <a:rPr lang="zh-CN" altLang="en-US" smtClean="0"/>
              <a:t>2022/3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7A14558-C8E9-4B2F-9ED6-F022C4AF8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2ABFE5B-80C9-4FB0-A5E2-B13976FAD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4CFB0-9A41-43D5-A341-C8895FC400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6458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696384-BB0F-4AB2-BC4A-3E4AD07E68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A59E2E3-6942-416F-9357-D3578F08EA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4962D35-6E1A-4386-94C2-EE175DE7C8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326AE25-7FC6-4BDD-824B-F0ADA0721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F81AD-6832-496E-A05F-ED678CE6D5CC}" type="datetimeFigureOut">
              <a:rPr lang="zh-CN" altLang="en-US" smtClean="0"/>
              <a:t>2022/3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B9F1F44-2EB7-4A8C-9FFB-4CFBED2627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5289279-4070-4CE3-B013-7362B051EF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4CFB0-9A41-43D5-A341-C8895FC400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4245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9C7141-09A5-45FE-9145-C92A2BC1A8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1D887C5-57F7-47F2-9958-70C9D25D28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F1F2A8A-0825-4BD7-98CD-3515A89B1E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EC55337-1CAA-48E1-96EC-E32D5EB093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F81AD-6832-496E-A05F-ED678CE6D5CC}" type="datetimeFigureOut">
              <a:rPr lang="zh-CN" altLang="en-US" smtClean="0"/>
              <a:t>2022/3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0D2519D-08B2-440C-AB8C-6955068D6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B8CC4AE-8E2D-41D8-A7CB-D08CAB651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4CFB0-9A41-43D5-A341-C8895FC400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2760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1DBB0F6-845C-4042-B977-3EBD8CB143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9EFCE17-D8DF-4843-B3CB-4470945BFC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6AE482E-4B26-4566-88C5-987D7DC1C0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DF81AD-6832-496E-A05F-ED678CE6D5CC}" type="datetimeFigureOut">
              <a:rPr lang="zh-CN" altLang="en-US" smtClean="0"/>
              <a:t>2022/3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5EDC23-B177-4931-8B4B-D3A5758E63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4E5DAAD-93EE-4900-86B1-841D1E8C06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A4CFB0-9A41-43D5-A341-C8895FC400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442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1FC1FB1-3DEE-4B6E-929B-F09580A789A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0" y="685800"/>
            <a:ext cx="7315200" cy="5486400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00DA1872-0228-4C20-9F12-FAA05E849DF9}"/>
              </a:ext>
            </a:extLst>
          </p:cNvPr>
          <p:cNvSpPr/>
          <p:nvPr/>
        </p:nvSpPr>
        <p:spPr>
          <a:xfrm>
            <a:off x="3215680" y="2492896"/>
            <a:ext cx="1224136" cy="5760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48231B8-10F0-458C-A7D6-5AC7D3377F8A}"/>
              </a:ext>
            </a:extLst>
          </p:cNvPr>
          <p:cNvSpPr txBox="1"/>
          <p:nvPr/>
        </p:nvSpPr>
        <p:spPr>
          <a:xfrm>
            <a:off x="3215680" y="2060848"/>
            <a:ext cx="1584176" cy="2880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 Leaf  Shoot</a:t>
            </a:r>
            <a:endParaRPr lang="zh-CN" altLang="en-US"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498A5D7-3285-4E55-9992-B1520F76F8EB}"/>
              </a:ext>
            </a:extLst>
          </p:cNvPr>
          <p:cNvSpPr txBox="1"/>
          <p:nvPr/>
        </p:nvSpPr>
        <p:spPr>
          <a:xfrm>
            <a:off x="4583832" y="3152002"/>
            <a:ext cx="98985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jCET1</a:t>
            </a:r>
            <a:endParaRPr lang="zh-CN" altLang="en-US"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2FBDB00-8163-4B7A-8515-80B030340FEE}"/>
              </a:ext>
            </a:extLst>
          </p:cNvPr>
          <p:cNvSpPr txBox="1"/>
          <p:nvPr/>
        </p:nvSpPr>
        <p:spPr>
          <a:xfrm>
            <a:off x="215152" y="140205"/>
            <a:ext cx="10399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41729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3E412816-8A4A-4EFA-A789-B1DC3B064F51}"/>
              </a:ext>
            </a:extLst>
          </p:cNvPr>
          <p:cNvSpPr txBox="1"/>
          <p:nvPr/>
        </p:nvSpPr>
        <p:spPr>
          <a:xfrm>
            <a:off x="367552" y="292605"/>
            <a:ext cx="10399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5AEACD37-44E4-45D5-97B5-319DC59F9B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6329" y="777688"/>
            <a:ext cx="7091083" cy="5318312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26E623BF-0850-4D96-B6A8-D8F83CCF5A4E}"/>
              </a:ext>
            </a:extLst>
          </p:cNvPr>
          <p:cNvSpPr/>
          <p:nvPr/>
        </p:nvSpPr>
        <p:spPr>
          <a:xfrm>
            <a:off x="3215680" y="2492896"/>
            <a:ext cx="1224136" cy="5760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5CDAE15-CDB1-4A21-AE35-63448FA62130}"/>
              </a:ext>
            </a:extLst>
          </p:cNvPr>
          <p:cNvSpPr txBox="1"/>
          <p:nvPr/>
        </p:nvSpPr>
        <p:spPr>
          <a:xfrm>
            <a:off x="3215680" y="2060848"/>
            <a:ext cx="1584176" cy="2880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 Leaf  Shoot</a:t>
            </a:r>
            <a:endParaRPr lang="zh-CN" altLang="en-US"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74F3F28-E755-4405-AB9C-4ECFB28886BF}"/>
              </a:ext>
            </a:extLst>
          </p:cNvPr>
          <p:cNvSpPr txBox="1"/>
          <p:nvPr/>
        </p:nvSpPr>
        <p:spPr>
          <a:xfrm>
            <a:off x="4583832" y="3152002"/>
            <a:ext cx="98985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jCET1</a:t>
            </a:r>
            <a:endParaRPr lang="zh-CN" altLang="en-US"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48204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15D726D-5684-4198-BC00-0574F28EBAB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0" y="685800"/>
            <a:ext cx="7315200" cy="5486400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20FE6823-4AC6-4A9A-8277-BDD86BC066E0}"/>
              </a:ext>
            </a:extLst>
          </p:cNvPr>
          <p:cNvSpPr/>
          <p:nvPr/>
        </p:nvSpPr>
        <p:spPr>
          <a:xfrm>
            <a:off x="4151784" y="3645024"/>
            <a:ext cx="1224136" cy="5760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2FD4A1B-BBCE-48C3-A603-81E3E79FE907}"/>
              </a:ext>
            </a:extLst>
          </p:cNvPr>
          <p:cNvSpPr txBox="1"/>
          <p:nvPr/>
        </p:nvSpPr>
        <p:spPr>
          <a:xfrm>
            <a:off x="4151784" y="3212976"/>
            <a:ext cx="1584176" cy="2880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 Leaf  Shoot</a:t>
            </a:r>
            <a:endParaRPr lang="zh-CN" altLang="en-US"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440E456-9F66-4B58-8E57-F997F7E2B01F}"/>
              </a:ext>
            </a:extLst>
          </p:cNvPr>
          <p:cNvSpPr txBox="1"/>
          <p:nvPr/>
        </p:nvSpPr>
        <p:spPr>
          <a:xfrm>
            <a:off x="5044432" y="4653137"/>
            <a:ext cx="98985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jACTIN</a:t>
            </a:r>
            <a:endParaRPr lang="zh-CN" altLang="en-US"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4D2B282-0FA7-4A76-B718-82DD892A552C}"/>
              </a:ext>
            </a:extLst>
          </p:cNvPr>
          <p:cNvSpPr txBox="1"/>
          <p:nvPr/>
        </p:nvSpPr>
        <p:spPr>
          <a:xfrm>
            <a:off x="215152" y="140205"/>
            <a:ext cx="10399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8794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CD8AEEE9-0609-4BB2-BABC-8F29516721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0" y="685800"/>
            <a:ext cx="7315200" cy="5486400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CF95677D-F1AB-40EA-B875-FD6CF93AC91D}"/>
              </a:ext>
            </a:extLst>
          </p:cNvPr>
          <p:cNvSpPr/>
          <p:nvPr/>
        </p:nvSpPr>
        <p:spPr>
          <a:xfrm>
            <a:off x="4151784" y="3645024"/>
            <a:ext cx="1224136" cy="5760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9B7EF22-2206-4FC7-B97F-DC39F96F669F}"/>
              </a:ext>
            </a:extLst>
          </p:cNvPr>
          <p:cNvSpPr txBox="1"/>
          <p:nvPr/>
        </p:nvSpPr>
        <p:spPr>
          <a:xfrm>
            <a:off x="4151784" y="3212976"/>
            <a:ext cx="1584176" cy="2880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 Leaf  Shoot</a:t>
            </a:r>
            <a:endParaRPr lang="zh-CN" altLang="en-US"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067F104-D60A-4207-87DB-DE4620982120}"/>
              </a:ext>
            </a:extLst>
          </p:cNvPr>
          <p:cNvSpPr txBox="1"/>
          <p:nvPr/>
        </p:nvSpPr>
        <p:spPr>
          <a:xfrm>
            <a:off x="5044432" y="4653137"/>
            <a:ext cx="98985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jACTIN</a:t>
            </a:r>
            <a:endParaRPr lang="zh-CN" altLang="en-US"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BE86EDA-985A-4151-BE02-B6E58EAC1D27}"/>
              </a:ext>
            </a:extLst>
          </p:cNvPr>
          <p:cNvSpPr txBox="1"/>
          <p:nvPr/>
        </p:nvSpPr>
        <p:spPr>
          <a:xfrm>
            <a:off x="215152" y="140205"/>
            <a:ext cx="10399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88290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26</Words>
  <Application>Microsoft Office PowerPoint</Application>
  <PresentationFormat>宽屏</PresentationFormat>
  <Paragraphs>14</Paragraphs>
  <Slides>4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沈 晨佳</dc:creator>
  <cp:lastModifiedBy>沈 晨佳</cp:lastModifiedBy>
  <cp:revision>2</cp:revision>
  <dcterms:created xsi:type="dcterms:W3CDTF">2022-03-12T01:29:00Z</dcterms:created>
  <dcterms:modified xsi:type="dcterms:W3CDTF">2022-03-17T00:31:27Z</dcterms:modified>
</cp:coreProperties>
</file>